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57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66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299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553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789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700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547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184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188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803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488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713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78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62924-7D75-407B-9D5E-F677C41F191E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8DEFF-8576-4175-884A-772EAFD5A6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20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340" y="2139897"/>
            <a:ext cx="5448080" cy="40080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457200" y="1770565"/>
            <a:ext cx="279762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use Embryo F7098 </a:t>
            </a:r>
            <a:r>
              <a:rPr kumimoji="0" lang="en-US" altLang="en-US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tA</a:t>
            </a:r>
            <a:endParaRPr kumimoji="0" lang="en-US" altLang="en-US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227587" y="316861"/>
            <a:ext cx="548708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Mouse Embryo R8108-8123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 smtClean="0"/>
              <a:t>PREDICTED</a:t>
            </a:r>
            <a:r>
              <a:rPr lang="en-US" altLang="en-US" sz="1400" dirty="0"/>
              <a:t>: Mus </a:t>
            </a:r>
            <a:r>
              <a:rPr lang="en-US" altLang="en-US" sz="1400" dirty="0" err="1"/>
              <a:t>musculus</a:t>
            </a:r>
            <a:r>
              <a:rPr lang="en-US" altLang="en-US" sz="1400" dirty="0"/>
              <a:t> inhibin beta-A (</a:t>
            </a:r>
            <a:r>
              <a:rPr lang="en-US" altLang="en-US" sz="1400" dirty="0" err="1"/>
              <a:t>Inhba</a:t>
            </a:r>
            <a:r>
              <a:rPr lang="en-US" altLang="en-US" sz="1400" dirty="0"/>
              <a:t>), transcript variant X1, mRNA </a:t>
            </a:r>
            <a:r>
              <a:rPr lang="en-US" altLang="en-US" sz="1400" dirty="0" smtClean="0"/>
              <a:t>Sequence </a:t>
            </a:r>
            <a:r>
              <a:rPr lang="en-US" altLang="en-US" sz="1400" dirty="0"/>
              <a:t>ID: </a:t>
            </a:r>
            <a:r>
              <a:rPr lang="en-US" altLang="en-US" sz="1400" dirty="0" smtClean="0"/>
              <a:t>XM_011244285</a:t>
            </a:r>
            <a:endParaRPr lang="en-US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/>
          <p:nvPr/>
        </p:nvPicPr>
        <p:blipFill>
          <a:blip r:embed="rId3"/>
          <a:stretch>
            <a:fillRect/>
          </a:stretch>
        </p:blipFill>
        <p:spPr>
          <a:xfrm>
            <a:off x="6227587" y="1203598"/>
            <a:ext cx="4996195" cy="504491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81189" y="297292"/>
            <a:ext cx="56403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2 Fig. Sanger Sequencing </a:t>
            </a:r>
            <a:r>
              <a:rPr lang="en-US" sz="1200" dirty="0" smtClean="0"/>
              <a:t>of RT-PCR products. </a:t>
            </a:r>
            <a:r>
              <a:rPr lang="en-US" sz="1200" dirty="0" smtClean="0"/>
              <a:t>PCR </a:t>
            </a:r>
            <a:r>
              <a:rPr lang="en-US" sz="1200" dirty="0"/>
              <a:t>products were size fractionated on 1% agarose gels, the bands were isolated, DNA was purified from the gel using Micro Bio-Spin columns (Bio-Rad) and subjected to sequencing, using primers listed in S Table 2. All Sanger DNA sequencing was performed by the Center for Applied Genomics (CAG; caglab.org) at the Children's Hospital of Philadelphia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37515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28661" y="167734"/>
            <a:ext cx="16065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use Embryo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145" y="749128"/>
            <a:ext cx="6400800" cy="49149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26084" y="1508251"/>
            <a:ext cx="18605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ouse Kidney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6084" y="2010494"/>
            <a:ext cx="4931159" cy="201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62661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9841" y="417311"/>
            <a:ext cx="2987677" cy="3886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use Liver R8108-8123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tA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841" y="947592"/>
            <a:ext cx="4317365" cy="44932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51302" y="870189"/>
            <a:ext cx="6505575" cy="377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86925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270" y="414439"/>
            <a:ext cx="4788657" cy="320656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13138" y="29630"/>
            <a:ext cx="2881947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use Liver F1485 </a:t>
            </a:r>
            <a:r>
              <a:rPr lang="en-US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tB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1766" y="3702927"/>
            <a:ext cx="4427923" cy="297378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18231" y="3823244"/>
            <a:ext cx="1503535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use Liver F1601 </a:t>
            </a:r>
            <a:r>
              <a:rPr lang="en-US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tB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68446" y="602992"/>
            <a:ext cx="4681257" cy="423246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046253" y="233660"/>
            <a:ext cx="1587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Uteru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2462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61</TotalTime>
  <Words>117</Words>
  <Application>Microsoft Office PowerPoint</Application>
  <PresentationFormat>Widescreen</PresentationFormat>
  <Paragraphs>1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he Children's Hospital of Philadelph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zzaro, Candice L</dc:creator>
  <cp:lastModifiedBy>Billings, Paul C</cp:lastModifiedBy>
  <cp:revision>11</cp:revision>
  <dcterms:created xsi:type="dcterms:W3CDTF">2019-12-05T15:44:27Z</dcterms:created>
  <dcterms:modified xsi:type="dcterms:W3CDTF">2020-01-06T18:28:14Z</dcterms:modified>
</cp:coreProperties>
</file>